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5292" autoAdjust="0"/>
    <p:restoredTop sz="94660"/>
  </p:normalViewPr>
  <p:slideViewPr>
    <p:cSldViewPr snapToGrid="0">
      <p:cViewPr varScale="1">
        <p:scale>
          <a:sx n="97" d="100"/>
          <a:sy n="97" d="100"/>
        </p:scale>
        <p:origin x="43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9397B10-EC2A-B47D-4DAF-F1285756F66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CADB718F-2F62-F3C8-CDBA-38BDF4EE047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BDEED67-A30A-81D6-87D3-316F281A4F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55315-43E4-42E4-9963-AECF36670351}" type="datetimeFigureOut">
              <a:rPr kumimoji="1" lang="ja-JP" altLang="en-US" smtClean="0"/>
              <a:t>2024/9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EBDA2BE-0DAF-3620-5132-CD4D6414B5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6678264-AF7A-B042-7460-533BF815EC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CBA22-963C-41C3-9DCA-9FBDD05858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01095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F0F8765-B1DA-224F-8EE5-433143CA91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2974691-6DB2-8266-F63D-40A4DC2E8C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5264055-6105-3231-E10E-2486F18D83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55315-43E4-42E4-9963-AECF36670351}" type="datetimeFigureOut">
              <a:rPr kumimoji="1" lang="ja-JP" altLang="en-US" smtClean="0"/>
              <a:t>2024/9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96424A4-95F5-AA0E-A1EF-77C9158AD6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5BD8D61-0C69-7D89-F6CA-18183F3838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CBA22-963C-41C3-9DCA-9FBDD05858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12766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D87D28AA-1DA9-A742-4B2D-2891F081A98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3FB338A-71C9-ABFD-4EA6-E90EB783CC0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DBF2726-DB4F-38B8-EDE0-BDF66930CD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55315-43E4-42E4-9963-AECF36670351}" type="datetimeFigureOut">
              <a:rPr kumimoji="1" lang="ja-JP" altLang="en-US" smtClean="0"/>
              <a:t>2024/9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B92FAAE-A5A6-94B9-3547-7929B83898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73AA8C8-434E-F184-2DF6-B147C68762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CBA22-963C-41C3-9DCA-9FBDD05858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18595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41844F4-2187-6089-0E35-9BB272FE83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3AEEEF6-5E6B-9B6E-0128-48B6238844F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BC2A003-041E-C14F-6911-C7F2175014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55315-43E4-42E4-9963-AECF36670351}" type="datetimeFigureOut">
              <a:rPr kumimoji="1" lang="ja-JP" altLang="en-US" smtClean="0"/>
              <a:t>2024/9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1877F0F-1702-94B3-4659-7DD0F532D5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3637BB6-A073-2FB0-C56A-C7F777C571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CBA22-963C-41C3-9DCA-9FBDD05858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487618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BAE5B61-D263-E463-6201-525508A553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CDD0CAA-85FC-FEB5-16BC-DB23502F1A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C8C3F7F-F532-3E99-A943-0581C71AD4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55315-43E4-42E4-9963-AECF36670351}" type="datetimeFigureOut">
              <a:rPr kumimoji="1" lang="ja-JP" altLang="en-US" smtClean="0"/>
              <a:t>2024/9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8D53910-8EA0-8F36-9257-13C267D3E3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1914EDD-CB1C-7BA0-968E-462F715BB9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CBA22-963C-41C3-9DCA-9FBDD05858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24769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E9477C0-E009-A3AF-9878-38F1C41228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94F2E40-64BA-85CF-CA2E-EC6FC65F905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A690E2C-7D97-1C2B-D745-1D5FEB0699D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88736A2-FB92-1FE5-E3B7-B724098FBD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55315-43E4-42E4-9963-AECF36670351}" type="datetimeFigureOut">
              <a:rPr kumimoji="1" lang="ja-JP" altLang="en-US" smtClean="0"/>
              <a:t>2024/9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75AF91E-086F-F056-91A9-21B328ACB7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BEB800E-E615-4A9E-D2F2-1797F09330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CBA22-963C-41C3-9DCA-9FBDD05858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17710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5D81BAF-982E-0858-B5D4-336EC15608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C6A18EE-B25D-F7A6-0844-974F767B5D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4EF3DF2-2A6B-2E23-4340-9351A1003CC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E3C61CD1-76E2-BA86-0161-C1A53A6F816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F941EBA1-D7B3-DF44-CDBD-6F0ACE02EB1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95105945-9E70-0C02-A791-0C30CB3B8D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55315-43E4-42E4-9963-AECF36670351}" type="datetimeFigureOut">
              <a:rPr kumimoji="1" lang="ja-JP" altLang="en-US" smtClean="0"/>
              <a:t>2024/9/2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8AD3EA7D-7436-8FE5-E2F5-0FDC879BD3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E90F632B-56C5-1809-58AA-54D47CCE03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CBA22-963C-41C3-9DCA-9FBDD05858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45695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2E03BF2-8C5F-F039-52E3-9C2F3F6447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0F47564E-1886-87DA-86A7-C8A36274BF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55315-43E4-42E4-9963-AECF36670351}" type="datetimeFigureOut">
              <a:rPr kumimoji="1" lang="ja-JP" altLang="en-US" smtClean="0"/>
              <a:t>2024/9/2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49691AD2-AEC5-CE9B-22CC-348F13CEC0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81D87CCA-58BF-0D50-D103-CD7D8FCA9B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CBA22-963C-41C3-9DCA-9FBDD05858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74546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6BE494F2-843E-157E-0A06-B25BD606E8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55315-43E4-42E4-9963-AECF36670351}" type="datetimeFigureOut">
              <a:rPr kumimoji="1" lang="ja-JP" altLang="en-US" smtClean="0"/>
              <a:t>2024/9/29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9AD7A768-C914-7ECB-12D7-F2134598CA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DD2AFAA-EE55-93EF-C5A2-922A841CAC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CBA22-963C-41C3-9DCA-9FBDD05858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13485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8571CA8-44A5-C2B0-0F3E-5975933242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7812716-F7C1-C45B-455E-CEFDD826324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ABDD09B-08B7-1AB0-03BF-625AC2752A6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B48B6CE-6320-A64C-5C62-E5734A36E7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55315-43E4-42E4-9963-AECF36670351}" type="datetimeFigureOut">
              <a:rPr kumimoji="1" lang="ja-JP" altLang="en-US" smtClean="0"/>
              <a:t>2024/9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B375252-1EED-164C-79E5-3BF90DEB81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1C3D2E3-A95E-992D-AA6C-8CD186E7F0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CBA22-963C-41C3-9DCA-9FBDD05858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37738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0443DF2-A722-CA3D-A181-7E11F187DC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6D0F2EA3-8899-5874-1E7B-6DE9DC447A7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83F076BF-AC8D-C58B-E61B-DF9A4351E00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58DB892-6AD4-E2F1-1F49-270AABD615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55315-43E4-42E4-9963-AECF36670351}" type="datetimeFigureOut">
              <a:rPr kumimoji="1" lang="ja-JP" altLang="en-US" smtClean="0"/>
              <a:t>2024/9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0DEECF2-0C3D-99CB-2F78-99919BA984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15F2530-AD7C-CC5C-58B2-7350B7770B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CBA22-963C-41C3-9DCA-9FBDD05858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97607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3DA52CA1-741C-3D47-5B10-6CA37B1677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E365419-A553-4991-D899-DCC84E35D6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CC0103A-F3FA-1B91-366C-9FDD3754FED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555315-43E4-42E4-9963-AECF36670351}" type="datetimeFigureOut">
              <a:rPr kumimoji="1" lang="ja-JP" altLang="en-US" smtClean="0"/>
              <a:t>2024/9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D1BDC01-2EF0-150C-865D-7BAA7A6E7B2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7B4BD83-0100-9744-4E35-80A656D13AB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2CBA22-963C-41C3-9DCA-9FBDD05858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5407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コンテンツ プレースホルダー 4">
            <a:extLst>
              <a:ext uri="{FF2B5EF4-FFF2-40B4-BE49-F238E27FC236}">
                <a16:creationId xmlns:a16="http://schemas.microsoft.com/office/drawing/2014/main" id="{6E48999C-0C1F-B8F5-5C70-CDCEC2419DB5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639547" y="844550"/>
            <a:ext cx="3921805" cy="4351338"/>
          </a:xfr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5EB3BC32-F126-8DA5-1FC1-EABD1AA92BBC}"/>
              </a:ext>
            </a:extLst>
          </p:cNvPr>
          <p:cNvSpPr txBox="1"/>
          <p:nvPr/>
        </p:nvSpPr>
        <p:spPr>
          <a:xfrm>
            <a:off x="1347168" y="2882324"/>
            <a:ext cx="1599389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2000" dirty="0">
                <a:latin typeface="Times New Roman" panose="02020603050405020304" pitchFamily="18" charset="0"/>
                <a:ea typeface="游明朝" panose="02020400000000000000" pitchFamily="18" charset="-128"/>
              </a:rPr>
              <a:t>C</a:t>
            </a:r>
            <a:r>
              <a:rPr lang="en-US" altLang="ja-JP" sz="20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uff pressure </a:t>
            </a:r>
          </a:p>
          <a:p>
            <a:pPr algn="ctr"/>
            <a:r>
              <a:rPr lang="en-US" altLang="ja-JP" sz="20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controller</a:t>
            </a:r>
            <a:endParaRPr lang="ja-JP" altLang="en-US" sz="2000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7E502E51-46C2-02F0-83F1-2456F8216D31}"/>
              </a:ext>
            </a:extLst>
          </p:cNvPr>
          <p:cNvSpPr txBox="1"/>
          <p:nvPr/>
        </p:nvSpPr>
        <p:spPr>
          <a:xfrm>
            <a:off x="7726770" y="1472202"/>
            <a:ext cx="1816771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ja-JP" sz="2400" b="0" i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op View</a:t>
            </a: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C03CD965-62F5-07DC-E4EC-63782C7B475C}"/>
              </a:ext>
            </a:extLst>
          </p:cNvPr>
          <p:cNvSpPr txBox="1"/>
          <p:nvPr/>
        </p:nvSpPr>
        <p:spPr>
          <a:xfrm>
            <a:off x="5760498" y="2719141"/>
            <a:ext cx="560441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an vertical</a:t>
            </a:r>
            <a:r>
              <a:rPr lang="ja-JP" alt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ngth = (A</a:t>
            </a:r>
            <a:r>
              <a:rPr kumimoji="1" lang="ja-JP" alt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＋</a:t>
            </a:r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kumimoji="1" lang="ja-JP" alt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＋</a:t>
            </a:r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kumimoji="1" lang="ja-JP" alt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＋</a:t>
            </a:r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)/</a:t>
            </a:r>
            <a:r>
              <a:rPr kumimoji="1" lang="ja-JP" alt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４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0059E566-EDBA-697E-7FD2-43F6253153F5}"/>
              </a:ext>
            </a:extLst>
          </p:cNvPr>
          <p:cNvSpPr txBox="1"/>
          <p:nvPr/>
        </p:nvSpPr>
        <p:spPr>
          <a:xfrm>
            <a:off x="6795321" y="3310827"/>
            <a:ext cx="247837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 = </a:t>
            </a:r>
            <a:r>
              <a:rPr lang="en-US" altLang="ja-JP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r>
              <a:rPr kumimoji="1" lang="en-US" altLang="ja-JP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×d×π</a:t>
            </a:r>
            <a:endParaRPr kumimoji="1" lang="ja-JP" altLang="en-US" sz="3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" name="直線矢印コネクタ 11">
            <a:extLst>
              <a:ext uri="{FF2B5EF4-FFF2-40B4-BE49-F238E27FC236}">
                <a16:creationId xmlns:a16="http://schemas.microsoft.com/office/drawing/2014/main" id="{B154FB09-1966-FFCA-2A0F-FB294DC45365}"/>
              </a:ext>
            </a:extLst>
          </p:cNvPr>
          <p:cNvCxnSpPr>
            <a:cxnSpLocks/>
          </p:cNvCxnSpPr>
          <p:nvPr/>
        </p:nvCxnSpPr>
        <p:spPr>
          <a:xfrm>
            <a:off x="3495675" y="5072063"/>
            <a:ext cx="1485900" cy="0"/>
          </a:xfrm>
          <a:prstGeom prst="straightConnector1">
            <a:avLst/>
          </a:prstGeom>
          <a:ln w="28575">
            <a:solidFill>
              <a:schemeClr val="tx1"/>
            </a:solidFill>
            <a:prstDash val="sysDash"/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69A38920-4220-275D-0DC8-3304ECD50510}"/>
              </a:ext>
            </a:extLst>
          </p:cNvPr>
          <p:cNvSpPr txBox="1"/>
          <p:nvPr/>
        </p:nvSpPr>
        <p:spPr>
          <a:xfrm>
            <a:off x="2946557" y="4810453"/>
            <a:ext cx="38504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kumimoji="1" lang="ja-JP" altLang="en-US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FFDB7813-DA67-B81D-2469-41D3AA001417}"/>
              </a:ext>
            </a:extLst>
          </p:cNvPr>
          <p:cNvSpPr txBox="1"/>
          <p:nvPr/>
        </p:nvSpPr>
        <p:spPr>
          <a:xfrm>
            <a:off x="2946557" y="2255020"/>
            <a:ext cx="4443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2C297FCE-12D0-6898-76C6-F7C5D752137E}"/>
              </a:ext>
            </a:extLst>
          </p:cNvPr>
          <p:cNvSpPr txBox="1"/>
          <p:nvPr/>
        </p:nvSpPr>
        <p:spPr>
          <a:xfrm>
            <a:off x="5055040" y="1855910"/>
            <a:ext cx="42832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06B1B38-AC9E-8046-D9EF-54741805E0C6}"/>
              </a:ext>
            </a:extLst>
          </p:cNvPr>
          <p:cNvSpPr txBox="1"/>
          <p:nvPr/>
        </p:nvSpPr>
        <p:spPr>
          <a:xfrm>
            <a:off x="6312996" y="3903534"/>
            <a:ext cx="4657685" cy="1569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r>
              <a:rPr kumimoji="1" lang="ja-JP" alt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：</a:t>
            </a:r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an vertical length</a:t>
            </a:r>
          </a:p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ja-JP" alt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：</a:t>
            </a:r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rface area</a:t>
            </a:r>
          </a:p>
          <a:p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kumimoji="1" lang="ja-JP" alt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：</a:t>
            </a:r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del trachea diameter</a:t>
            </a:r>
          </a:p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π</a:t>
            </a:r>
            <a:r>
              <a:rPr kumimoji="1" lang="ja-JP" alt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：</a:t>
            </a:r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io of a circle’s circumference</a:t>
            </a:r>
          </a:p>
        </p:txBody>
      </p:sp>
      <p:pic>
        <p:nvPicPr>
          <p:cNvPr id="15" name="図 14">
            <a:extLst>
              <a:ext uri="{FF2B5EF4-FFF2-40B4-BE49-F238E27FC236}">
                <a16:creationId xmlns:a16="http://schemas.microsoft.com/office/drawing/2014/main" id="{ECDBC730-2AB6-C39E-07E0-1F378A5ABE8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76284" y="749918"/>
            <a:ext cx="1816771" cy="1906233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9E77DAA5-62BC-CAC2-16C9-6D7325AC9079}"/>
              </a:ext>
            </a:extLst>
          </p:cNvPr>
          <p:cNvSpPr txBox="1"/>
          <p:nvPr/>
        </p:nvSpPr>
        <p:spPr>
          <a:xfrm>
            <a:off x="6312996" y="1472201"/>
            <a:ext cx="74334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ff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372860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4</TotalTime>
  <Words>51</Words>
  <Application>Microsoft Office PowerPoint</Application>
  <PresentationFormat>ワイド画面</PresentationFormat>
  <Paragraphs>1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淳一 道越</dc:creator>
  <cp:lastModifiedBy>淳一 道越</cp:lastModifiedBy>
  <cp:revision>10</cp:revision>
  <dcterms:created xsi:type="dcterms:W3CDTF">2024-08-22T23:14:38Z</dcterms:created>
  <dcterms:modified xsi:type="dcterms:W3CDTF">2024-09-29T07:28:37Z</dcterms:modified>
</cp:coreProperties>
</file>